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25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300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869CA7E-B157-4CE3-BA3F-7C0105231A3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483E04D-304E-404B-88C5-314F8B62E55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ED17A35-CA58-4F8C-BADD-DECB236A1A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098DAF-435F-4CC6-8ED2-C5F38453F986}" type="datetimeFigureOut">
              <a:rPr lang="en-US" smtClean="0"/>
              <a:t>9/8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477A234-BAA9-4D03-9B26-2A5E9A1579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699017B-C8EF-442E-840F-D8022519D9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5BF485-DC73-40BD-82D7-CC1B597B05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44972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D8A3A28-5723-499B-B4F0-9E4A86BC8BA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4312C5D-9B3E-4EA8-8E07-E3DEB30569C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3A5206A-9D2B-42F7-B17C-86EF96C4FD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098DAF-435F-4CC6-8ED2-C5F38453F986}" type="datetimeFigureOut">
              <a:rPr lang="en-US" smtClean="0"/>
              <a:t>9/8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D3B61EB-A592-439D-A07B-9EF8BE90D1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D8A063D-641D-4D54-BCA4-18CD95A42D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5BF485-DC73-40BD-82D7-CC1B597B05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77497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B8E6320-D662-4426-97DC-EE290EE600A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CB8E7BC-EEBB-4DE2-820A-CC9544F2F9C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47E3B09-A7FF-4B45-94D4-8EC12C3501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098DAF-435F-4CC6-8ED2-C5F38453F986}" type="datetimeFigureOut">
              <a:rPr lang="en-US" smtClean="0"/>
              <a:t>9/8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6ADE7B2-471E-4D9E-BCD7-CDF41D8617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3E68778-6C0B-4779-B135-D445AB0859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5BF485-DC73-40BD-82D7-CC1B597B05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68136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720A2F-9D8B-41C1-90E7-B161AEBAEF3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7236DB2-C344-4E69-8A8B-E9266E7A1A2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77EA787-FC57-4DC7-8E9C-82000CD094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098DAF-435F-4CC6-8ED2-C5F38453F986}" type="datetimeFigureOut">
              <a:rPr lang="en-US" smtClean="0"/>
              <a:t>9/8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DC82593-7359-4D72-8319-16B2D3F71C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E60E358-DDAF-4262-B119-B890F07D7A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5BF485-DC73-40BD-82D7-CC1B597B05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15144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C9E53BA-D68B-46EC-941F-43014D5BF72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1E077AC-B3E0-42F0-AFD0-096FAEADFDE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9B5587A-7FB8-4148-A324-089961109A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098DAF-435F-4CC6-8ED2-C5F38453F986}" type="datetimeFigureOut">
              <a:rPr lang="en-US" smtClean="0"/>
              <a:t>9/8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B77AD50-E274-417B-94D0-0A67CC75D4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BBA7088-5B70-4767-AD20-72A81C3446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5BF485-DC73-40BD-82D7-CC1B597B05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22969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1E9651B-1BA9-4454-B5B2-F23F48BD322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E3E3098-9EFB-4361-B8D9-B6D89F83D95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BB6FE53-3725-4221-84EE-4043877457A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C26F535-50FD-4B4E-9430-4223872764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098DAF-435F-4CC6-8ED2-C5F38453F986}" type="datetimeFigureOut">
              <a:rPr lang="en-US" smtClean="0"/>
              <a:t>9/8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90EA8E9-7ADD-4BDF-9A5F-6AEA32D268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8CAED79-EF35-4AF8-B2BF-D14779010A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5BF485-DC73-40BD-82D7-CC1B597B05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90830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8AFC716-3986-418F-9B60-65F84992D69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629C6EA-1384-4A92-8A50-BB007A164AD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AA834D3-88B7-4191-8857-7D1E70D4FA6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D9F864D-175B-4CFE-912E-A967DFEA3C5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24F7908-951C-406B-9596-9FDBB9D2156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51E5FDC-51A5-4EA8-8A7A-AF7F661DB6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098DAF-435F-4CC6-8ED2-C5F38453F986}" type="datetimeFigureOut">
              <a:rPr lang="en-US" smtClean="0"/>
              <a:t>9/8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768358E-FB76-475D-947E-70BC221584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17EF4B6-B450-4128-8F0F-E43BB4B0A3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5BF485-DC73-40BD-82D7-CC1B597B05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1413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F1063E2-9D41-4E45-8944-2B875CB3DA7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9682480-5DC9-490F-966F-06AD271499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098DAF-435F-4CC6-8ED2-C5F38453F986}" type="datetimeFigureOut">
              <a:rPr lang="en-US" smtClean="0"/>
              <a:t>9/8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D6CAC40-9CDA-4E46-80CE-936A2C3937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FAA68DE-1103-424F-8A7F-9D78109D75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5BF485-DC73-40BD-82D7-CC1B597B05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93683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BC42C53-98C9-4A0C-A414-1FB731CA6E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098DAF-435F-4CC6-8ED2-C5F38453F986}" type="datetimeFigureOut">
              <a:rPr lang="en-US" smtClean="0"/>
              <a:t>9/8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C85A783-4F55-45D0-9818-314D9FB1A0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601CFEB-FCFD-40E3-88E6-E97C5989D4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5BF485-DC73-40BD-82D7-CC1B597B05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32320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9DA482B-F888-4931-8976-61899F3F187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AE6F999-3710-473B-8875-6B592DF1AF9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8C805C4-6575-40A4-95AF-536BB219E6B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42F653F-3F2E-4481-8A55-A86793B1C9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098DAF-435F-4CC6-8ED2-C5F38453F986}" type="datetimeFigureOut">
              <a:rPr lang="en-US" smtClean="0"/>
              <a:t>9/8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D4BAB1B-D958-49D2-BCEE-7CBFB409AC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016FCAC-79AC-45E4-ABAF-57BA5D9C0F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5BF485-DC73-40BD-82D7-CC1B597B05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86045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C24E182-B9FF-4E3A-AC2B-D62E1928500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26995605-8A39-4D62-87EA-5B07FF1B332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799A503-03B8-4DB2-9E28-65812726FF5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73E175E-3DA8-4B23-811E-2CCE548BFA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098DAF-435F-4CC6-8ED2-C5F38453F986}" type="datetimeFigureOut">
              <a:rPr lang="en-US" smtClean="0"/>
              <a:t>9/8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7C5E133-20C9-4F13-A092-A5968CE47F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38BD467-048B-499C-B41A-00B32B1E52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5BF485-DC73-40BD-82D7-CC1B597B05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84006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F1B6270-8401-4017-8AEA-79E69D58213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20D900E-59EB-4721-92DE-DBA28799507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BB2142E-34BF-4664-A876-0A139C14B49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E098DAF-435F-4CC6-8ED2-C5F38453F986}" type="datetimeFigureOut">
              <a:rPr lang="en-US" smtClean="0"/>
              <a:t>9/8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90CFAEB-6BF9-46A0-ACC6-FB818FBCD1E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8D5D3B8-D711-4F6A-91E3-52CBDC290DC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D5BF485-DC73-40BD-82D7-CC1B597B05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89483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DC932AEE-AF31-4533-BB38-310A01F80BA4}"/>
              </a:ext>
            </a:extLst>
          </p:cNvPr>
          <p:cNvGrpSpPr/>
          <p:nvPr/>
        </p:nvGrpSpPr>
        <p:grpSpPr>
          <a:xfrm>
            <a:off x="133352" y="1055473"/>
            <a:ext cx="11256500" cy="5727490"/>
            <a:chOff x="733427" y="131548"/>
            <a:chExt cx="11256500" cy="5727490"/>
          </a:xfrm>
        </p:grpSpPr>
        <p:sp>
          <p:nvSpPr>
            <p:cNvPr id="5" name="TextBox 4"/>
            <p:cNvSpPr txBox="1"/>
            <p:nvPr/>
          </p:nvSpPr>
          <p:spPr>
            <a:xfrm>
              <a:off x="2362201" y="131548"/>
              <a:ext cx="7231792" cy="276999"/>
            </a:xfrm>
            <a:prstGeom prst="rect">
              <a:avLst/>
            </a:prstGeom>
          </p:spPr>
          <p:style>
            <a:lnRef idx="1">
              <a:schemeClr val="accent3"/>
            </a:lnRef>
            <a:fillRef idx="2">
              <a:schemeClr val="accent3"/>
            </a:fillRef>
            <a:effectRef idx="1">
              <a:schemeClr val="accent3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pPr lvl="0"/>
              <a:r>
                <a:rPr lang="en-US" sz="1200" b="1" dirty="0">
                  <a:solidFill>
                    <a:schemeClr val="tx1"/>
                  </a:solidFill>
                  <a:latin typeface="Arial" panose="020B0604020202020204" pitchFamily="34" charset="0"/>
                </a:rPr>
                <a:t>NHANES III , both phases (1988-1994:1-90y)</a:t>
              </a:r>
              <a:r>
                <a:rPr lang="en-US" sz="1200" dirty="0">
                  <a:solidFill>
                    <a:schemeClr val="tx1"/>
                  </a:solidFill>
                  <a:latin typeface="Arial" panose="020B0604020202020204" pitchFamily="34" charset="0"/>
                </a:rPr>
                <a:t>:</a:t>
              </a:r>
              <a:r>
                <a:rPr lang="en-US" sz="1200" b="1" dirty="0">
                  <a:solidFill>
                    <a:schemeClr val="tx1"/>
                  </a:solidFill>
                  <a:latin typeface="Arial" panose="020B0604020202020204" pitchFamily="34" charset="0"/>
                </a:rPr>
                <a:t> N=33,199</a:t>
              </a:r>
            </a:p>
          </p:txBody>
        </p:sp>
        <p:sp>
          <p:nvSpPr>
            <p:cNvPr id="6" name="Down Arrow 5"/>
            <p:cNvSpPr/>
            <p:nvPr/>
          </p:nvSpPr>
          <p:spPr>
            <a:xfrm>
              <a:off x="5906530" y="422237"/>
              <a:ext cx="189470" cy="960982"/>
            </a:xfrm>
            <a:prstGeom prst="downArrow">
              <a:avLst/>
            </a:pr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2362201" y="1387731"/>
              <a:ext cx="7305673" cy="461665"/>
            </a:xfrm>
            <a:prstGeom prst="rect">
              <a:avLst/>
            </a:prstGeom>
          </p:spPr>
          <p:style>
            <a:lnRef idx="1">
              <a:schemeClr val="accent3"/>
            </a:lnRef>
            <a:fillRef idx="2">
              <a:schemeClr val="accent3"/>
            </a:fillRef>
            <a:effectRef idx="1">
              <a:schemeClr val="accent3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Baseline Age ≥ 60 years</a:t>
              </a:r>
            </a:p>
            <a:p>
              <a:pPr lvl="0" algn="ctr"/>
              <a:r>
                <a:rPr lang="en-US" sz="12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HANES III (both phases):N=6,596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Right Arrow 8"/>
            <p:cNvSpPr/>
            <p:nvPr/>
          </p:nvSpPr>
          <p:spPr>
            <a:xfrm>
              <a:off x="6087756" y="812180"/>
              <a:ext cx="3047999" cy="214184"/>
            </a:xfrm>
            <a:prstGeom prst="rightArrow">
              <a:avLst/>
            </a:pr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9172575" y="685646"/>
              <a:ext cx="2241191" cy="461665"/>
            </a:xfrm>
            <a:prstGeom prst="rect">
              <a:avLst/>
            </a:prstGeom>
          </p:spPr>
          <p:style>
            <a:lnRef idx="1">
              <a:schemeClr val="accent3"/>
            </a:lnRef>
            <a:fillRef idx="2">
              <a:schemeClr val="accent3"/>
            </a:fillRef>
            <a:effectRef idx="1">
              <a:schemeClr val="accent3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pPr lvl="0"/>
              <a:r>
                <a:rPr lang="en-US" sz="1200" b="1" dirty="0">
                  <a:solidFill>
                    <a:schemeClr val="tx1"/>
                  </a:solidFill>
                  <a:latin typeface="Arial" panose="020B0604020202020204" pitchFamily="34" charset="0"/>
                </a:rPr>
                <a:t>Age&lt;60y exclusion</a:t>
              </a:r>
              <a:r>
                <a:rPr lang="en-US" sz="1200" dirty="0">
                  <a:solidFill>
                    <a:schemeClr val="tx1"/>
                  </a:solidFill>
                  <a:latin typeface="Arial" panose="020B0604020202020204" pitchFamily="34" charset="0"/>
                </a:rPr>
                <a:t>: </a:t>
              </a:r>
            </a:p>
            <a:p>
              <a:pPr lvl="0"/>
              <a:r>
                <a:rPr lang="en-US" sz="1200" dirty="0">
                  <a:solidFill>
                    <a:schemeClr val="tx1"/>
                  </a:solidFill>
                  <a:latin typeface="Arial" panose="020B0604020202020204" pitchFamily="34" charset="0"/>
                </a:rPr>
                <a:t>N=26,603</a:t>
              </a:r>
            </a:p>
          </p:txBody>
        </p:sp>
        <p:sp>
          <p:nvSpPr>
            <p:cNvPr id="19" name="Down Arrow 18"/>
            <p:cNvSpPr/>
            <p:nvPr/>
          </p:nvSpPr>
          <p:spPr>
            <a:xfrm>
              <a:off x="5960074" y="1862929"/>
              <a:ext cx="152394" cy="1271272"/>
            </a:xfrm>
            <a:prstGeom prst="downArrow">
              <a:avLst/>
            </a:pr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2286001" y="3220527"/>
              <a:ext cx="7524750" cy="646331"/>
            </a:xfrm>
            <a:prstGeom prst="rect">
              <a:avLst/>
            </a:prstGeom>
          </p:spPr>
          <p:style>
            <a:lnRef idx="1">
              <a:schemeClr val="accent3"/>
            </a:lnRef>
            <a:fillRef idx="2">
              <a:schemeClr val="accent3"/>
            </a:fillRef>
            <a:effectRef idx="1">
              <a:schemeClr val="accent3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pPr lvl="0" algn="ctr"/>
              <a:r>
                <a:rPr lang="en-US" sz="1200" b="1" dirty="0">
                  <a:solidFill>
                    <a:schemeClr val="tx1"/>
                  </a:solidFill>
                  <a:latin typeface="Arial" panose="020B0604020202020204" pitchFamily="34" charset="0"/>
                </a:rPr>
                <a:t>Baseline age≥60y and complete data on </a:t>
              </a:r>
              <a:r>
                <a:rPr lang="en-US" sz="1200" b="1" i="1" dirty="0">
                  <a:solidFill>
                    <a:schemeClr val="tx1"/>
                  </a:solidFill>
                  <a:latin typeface="Arial" panose="020B0604020202020204" pitchFamily="34" charset="0"/>
                </a:rPr>
                <a:t>cognitive performance score</a:t>
              </a:r>
            </a:p>
            <a:p>
              <a:pPr lvl="0" algn="ctr"/>
              <a:r>
                <a:rPr lang="en-US" sz="12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HANES III (both phases):N=4,734 </a:t>
              </a:r>
            </a:p>
            <a:p>
              <a:pPr lvl="0"/>
              <a:endParaRPr lang="en-US" sz="12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Right Arrow 20"/>
            <p:cNvSpPr/>
            <p:nvPr/>
          </p:nvSpPr>
          <p:spPr>
            <a:xfrm>
              <a:off x="6089557" y="2251463"/>
              <a:ext cx="3047999" cy="214184"/>
            </a:xfrm>
            <a:prstGeom prst="rightArrow">
              <a:avLst/>
            </a:pr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9173359" y="2035721"/>
              <a:ext cx="2730843" cy="646331"/>
            </a:xfrm>
            <a:prstGeom prst="rect">
              <a:avLst/>
            </a:prstGeom>
          </p:spPr>
          <p:style>
            <a:lnRef idx="1">
              <a:schemeClr val="accent3"/>
            </a:lnRef>
            <a:fillRef idx="2">
              <a:schemeClr val="accent3"/>
            </a:fillRef>
            <a:effectRef idx="1">
              <a:schemeClr val="accent3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Missing cognitive performance data:</a:t>
              </a:r>
            </a:p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Both phases: N=1,862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Down Arrow 30"/>
            <p:cNvSpPr/>
            <p:nvPr/>
          </p:nvSpPr>
          <p:spPr>
            <a:xfrm>
              <a:off x="5960076" y="3899725"/>
              <a:ext cx="152392" cy="1118791"/>
            </a:xfrm>
            <a:prstGeom prst="downArrow">
              <a:avLst/>
            </a:pr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733427" y="5028041"/>
              <a:ext cx="10648948" cy="830997"/>
            </a:xfrm>
            <a:prstGeom prst="rect">
              <a:avLst/>
            </a:prstGeom>
          </p:spPr>
          <p:style>
            <a:lnRef idx="1">
              <a:schemeClr val="accent3"/>
            </a:lnRef>
            <a:fillRef idx="2">
              <a:schemeClr val="accent3"/>
            </a:fillRef>
            <a:effectRef idx="1">
              <a:schemeClr val="accent3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pPr lvl="0" algn="ctr"/>
              <a:r>
                <a:rPr lang="en-US" sz="1200" b="1" dirty="0">
                  <a:solidFill>
                    <a:schemeClr val="tx1"/>
                  </a:solidFill>
                  <a:latin typeface="Arial" panose="020B0604020202020204" pitchFamily="34" charset="0"/>
                </a:rPr>
                <a:t>Baseline age≥60y, complete data on</a:t>
              </a:r>
              <a:r>
                <a:rPr lang="en-US" sz="1200" b="1" i="1" dirty="0">
                  <a:solidFill>
                    <a:schemeClr val="tx1"/>
                  </a:solidFill>
                  <a:latin typeface="Arial" panose="020B0604020202020204" pitchFamily="34" charset="0"/>
                </a:rPr>
                <a:t> cognitive performance score and CMS-Medicare exclusion</a:t>
              </a:r>
            </a:p>
            <a:p>
              <a:pPr lvl="0"/>
              <a:endParaRPr lang="en-US" sz="12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lvl="0"/>
              <a:r>
                <a:rPr lang="en-US" sz="12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HANES III (both phases):N=4,592:  Lowest income group N=1,451  ; Middle income group N=1,830  ; Highest income group N</a:t>
              </a:r>
              <a:r>
                <a:rPr lang="en-US" sz="1200" b="1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=1,311</a:t>
              </a:r>
              <a:endParaRPr lang="en-US" sz="12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lvl="0"/>
              <a:r>
                <a:rPr lang="en-US" sz="1200" b="1" i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cident all-cause dementia: n=1,606</a:t>
              </a:r>
              <a:endParaRPr lang="en-US" sz="12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Right Arrow 32"/>
            <p:cNvSpPr/>
            <p:nvPr/>
          </p:nvSpPr>
          <p:spPr>
            <a:xfrm>
              <a:off x="6083893" y="4193336"/>
              <a:ext cx="3047999" cy="214184"/>
            </a:xfrm>
            <a:prstGeom prst="rightArrow">
              <a:avLst/>
            </a:pr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4" name="TextBox 33"/>
            <p:cNvSpPr txBox="1"/>
            <p:nvPr/>
          </p:nvSpPr>
          <p:spPr>
            <a:xfrm>
              <a:off x="9174619" y="4080284"/>
              <a:ext cx="2815308" cy="461665"/>
            </a:xfrm>
            <a:prstGeom prst="rect">
              <a:avLst/>
            </a:prstGeom>
          </p:spPr>
          <p:style>
            <a:lnRef idx="1">
              <a:schemeClr val="accent3"/>
            </a:lnRef>
            <a:fillRef idx="2">
              <a:schemeClr val="accent3"/>
            </a:fillRef>
            <a:effectRef idx="1">
              <a:schemeClr val="accent3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MS-Medicare exclusion:</a:t>
              </a:r>
            </a:p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Both phases: N=142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" name="TextBox 2">
            <a:extLst>
              <a:ext uri="{FF2B5EF4-FFF2-40B4-BE49-F238E27FC236}">
                <a16:creationId xmlns:a16="http://schemas.microsoft.com/office/drawing/2014/main" id="{47B8EEE7-D14A-4CE4-8643-C49D85FA73A0}"/>
              </a:ext>
            </a:extLst>
          </p:cNvPr>
          <p:cNvSpPr txBox="1"/>
          <p:nvPr/>
        </p:nvSpPr>
        <p:spPr>
          <a:xfrm>
            <a:off x="304800" y="247649"/>
            <a:ext cx="15621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IGURE S1.</a:t>
            </a:r>
          </a:p>
        </p:txBody>
      </p:sp>
    </p:spTree>
    <p:extLst>
      <p:ext uri="{BB962C8B-B14F-4D97-AF65-F5344CB8AC3E}">
        <p14:creationId xmlns:p14="http://schemas.microsoft.com/office/powerpoint/2010/main" val="14586739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10</TotalTime>
  <Words>127</Words>
  <Application>Microsoft Office PowerPoint</Application>
  <PresentationFormat>Widescreen</PresentationFormat>
  <Paragraphs>1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aydoun, May Ahmad (NIH/NIA/IRP) [E]</dc:creator>
  <cp:lastModifiedBy>Baydoun, May Ahmad (NIH/NIA/IRP) [E]</cp:lastModifiedBy>
  <cp:revision>52</cp:revision>
  <cp:lastPrinted>2019-07-01T20:07:46Z</cp:lastPrinted>
  <dcterms:created xsi:type="dcterms:W3CDTF">2019-07-01T19:18:34Z</dcterms:created>
  <dcterms:modified xsi:type="dcterms:W3CDTF">2022-09-08T17:22:47Z</dcterms:modified>
</cp:coreProperties>
</file>